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69" autoAdjust="0"/>
    <p:restoredTop sz="94660"/>
  </p:normalViewPr>
  <p:slideViewPr>
    <p:cSldViewPr snapToGrid="0">
      <p:cViewPr varScale="1">
        <p:scale>
          <a:sx n="81" d="100"/>
          <a:sy n="81" d="100"/>
        </p:scale>
        <p:origin x="67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1FAE928-EACC-45B7-A0FA-15CC53215BE9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AF844C-0003-40E3-B4EE-12DC29040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0898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C0E8B6-7D40-4B96-9D2E-D6F53E780AD7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72675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C95315-7733-F575-4AB8-6F3C7AFA3E7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E64F80E-AE1C-91C7-E156-BA2609BC13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D22364-D289-A7FF-C17F-EF9323B2C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154EFA-2B40-62D8-74A9-DE9A1EBAD4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2AEAF5A-EE68-4F47-7390-29A1DF5DF9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4802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B979CF-FB3D-4851-3D67-D4DA8AB192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E28E0B9-10A7-65DF-211D-4CD5EBDE1A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FAF1221-1189-F1F7-1983-8D3B8DAF32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8B5A57-B066-8326-A1EC-6AAB5E68B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B64015D-5A37-DDC6-293D-CFAE075C49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94708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599263A-CB57-F916-C4E4-B955A919A2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B80A416-F631-5077-CFED-E825B775AA9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E2D365-8377-575F-07C5-1009019E39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EF374B7-04EE-2C1B-76D5-0041A4CB9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0BAA16-C18C-47B0-6E6E-CA29F05036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772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D4DD94F-0738-2A86-E954-B187D784FA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D1B91AE-FAE1-6335-4863-37ED9384164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1AEA70E-96D4-1F37-1A4E-607E9C9C1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CB5136F-C5A7-0EC2-1D3E-DC09458760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427E00-9B1E-24CB-07E4-CBD8A4F835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75555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E10E7A-AEF0-B115-544A-450BB0ACC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C827015-499B-9846-5F7F-1D75FA97AA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A1ECD4-F203-A58A-FF5C-8A6F73C8F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141429D-6C91-BF46-7208-D5F355B705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CE51410-9C44-2035-B2A5-D5F8A8D26A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2276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1CC88B0-4CE9-6D32-A994-66AD1CAD7F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03D21F4-75A4-CC93-5D6C-D88E9448FA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65A5F84-69D8-0C2F-5D13-3211E39F65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0B19F52-2E39-26CF-C7B3-48640915D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4BE013C-FAC0-FBBF-174E-D4419B8EB3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E151CA-ED4A-5793-3886-4C1627C86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69272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F89D23A-5DD6-05C1-4267-F856E34DAB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A778FF4-2EB7-F4F6-F9C8-A4363CB95E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D2F88C2-A91B-DB24-539B-36ABADC1B0A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ECB79FC-5E51-05AF-08B6-87AD266550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6193F682-ABA5-64F7-4F35-F7E819B1A06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AA89FBC-0EAE-5F9A-82F4-FEB7D36640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186561C-D074-9B76-2E81-D5DBA4515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D87614E-095C-A2C7-F0C8-824A8F45B7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166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20B79E5-92D4-1CCD-A844-FAE1C8C447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CB20704C-E726-070D-8DC4-A697E82639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6285FDC-8A92-D684-F5CE-651A70FEE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C9538C0E-1FE5-649F-E1DE-76C54359A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5361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E194D92F-32C1-249C-7C7E-27D8CF7E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2D175DE-DEBD-6E33-A9ED-B641099676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C3F18E8-D14D-BDDD-64C2-C4BB7B582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4548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FFDB86F-F4ED-5004-B61E-FB1462840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88664E2-DCCC-9B71-E768-1372B73DDA1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47F63FD-8A20-874B-0E80-C5AFC384562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B757182-026D-C029-65BC-04C0C99B8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96392B-0B48-4E59-F671-4B09ABC8D0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DA4F66-457A-70A4-431E-9B57C60AD9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8426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3D8401-E330-1494-2635-EF0EE17CE4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25C3B62-FA42-1198-F6A2-2C948CC9E2E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DFE0F7A-4C5C-A548-82B8-81C8A9B235E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A9FF0A9-6695-8B55-1959-EF78C3C75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684BC6-92EA-548E-7CEC-2D587B09B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CFACABC-6235-91C0-705C-C7851567B1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01111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B9A0742-E929-DC86-D187-2C94B3C66B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AAD4E0B-5716-4AB7-D02E-1E66F18F40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E7816C9-1A75-8E1A-2288-08913F1501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CF08BC-9E5D-49D2-9AE8-7F8BFD3EF988}" type="datetimeFigureOut">
              <a:rPr lang="zh-CN" altLang="en-US" smtClean="0"/>
              <a:t>2025/2/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71B969-C4C2-A5A5-C12B-D76DC2A07B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FEF97B-7CE0-D8D5-E86F-F1491486440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61DF91-E4F6-4225-85D6-B3E3B5C7F0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43311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7" name="组合 86"/>
          <p:cNvGrpSpPr/>
          <p:nvPr/>
        </p:nvGrpSpPr>
        <p:grpSpPr>
          <a:xfrm>
            <a:off x="3463573" y="1032944"/>
            <a:ext cx="5264854" cy="4792112"/>
            <a:chOff x="3307616" y="901862"/>
            <a:chExt cx="5264854" cy="4792112"/>
          </a:xfrm>
        </p:grpSpPr>
        <p:grpSp>
          <p:nvGrpSpPr>
            <p:cNvPr id="2" name="组合 1"/>
            <p:cNvGrpSpPr/>
            <p:nvPr/>
          </p:nvGrpSpPr>
          <p:grpSpPr>
            <a:xfrm>
              <a:off x="3572766" y="3279210"/>
              <a:ext cx="4956093" cy="2414764"/>
              <a:chOff x="1546396" y="2945709"/>
              <a:chExt cx="4956093" cy="2414764"/>
            </a:xfrm>
          </p:grpSpPr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E850C520-E903-CE4A-ECD8-11A9C26C8F2E}"/>
                  </a:ext>
                </a:extLst>
              </p:cNvPr>
              <p:cNvSpPr txBox="1"/>
              <p:nvPr/>
            </p:nvSpPr>
            <p:spPr>
              <a:xfrm>
                <a:off x="1573315" y="4961408"/>
                <a:ext cx="61348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bp-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30AFB6E5-F823-2B55-1B7B-7760973B1E5C}"/>
                  </a:ext>
                </a:extLst>
              </p:cNvPr>
              <p:cNvSpPr txBox="1"/>
              <p:nvPr/>
            </p:nvSpPr>
            <p:spPr>
              <a:xfrm>
                <a:off x="1546396" y="4812371"/>
                <a:ext cx="64040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0bp-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4674846B-C45E-CF99-9C9F-8DCCC57502C9}"/>
                  </a:ext>
                </a:extLst>
              </p:cNvPr>
              <p:cNvSpPr txBox="1"/>
              <p:nvPr/>
            </p:nvSpPr>
            <p:spPr>
              <a:xfrm>
                <a:off x="2335422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文本框 5">
                <a:extLst>
                  <a:ext uri="{FF2B5EF4-FFF2-40B4-BE49-F238E27FC236}">
                    <a16:creationId xmlns:a16="http://schemas.microsoft.com/office/drawing/2014/main" id="{75C5B0C7-F159-D755-B9B2-42C1E11734BD}"/>
                  </a:ext>
                </a:extLst>
              </p:cNvPr>
              <p:cNvSpPr txBox="1"/>
              <p:nvPr/>
            </p:nvSpPr>
            <p:spPr>
              <a:xfrm>
                <a:off x="2586294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2B1A5674-38E9-0BA4-7F4D-4EB2CEA4659A}"/>
                  </a:ext>
                </a:extLst>
              </p:cNvPr>
              <p:cNvSpPr txBox="1"/>
              <p:nvPr/>
            </p:nvSpPr>
            <p:spPr>
              <a:xfrm>
                <a:off x="2837166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文本框 7">
                <a:extLst>
                  <a:ext uri="{FF2B5EF4-FFF2-40B4-BE49-F238E27FC236}">
                    <a16:creationId xmlns:a16="http://schemas.microsoft.com/office/drawing/2014/main" id="{905FACEF-7F66-F676-3DE6-1C9E13DB9B55}"/>
                  </a:ext>
                </a:extLst>
              </p:cNvPr>
              <p:cNvSpPr txBox="1"/>
              <p:nvPr/>
            </p:nvSpPr>
            <p:spPr>
              <a:xfrm>
                <a:off x="3088038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7B66C259-EC9D-66A0-5F0D-EAF216065C71}"/>
                  </a:ext>
                </a:extLst>
              </p:cNvPr>
              <p:cNvSpPr txBox="1"/>
              <p:nvPr/>
            </p:nvSpPr>
            <p:spPr>
              <a:xfrm>
                <a:off x="3338910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文本框 9">
                <a:extLst>
                  <a:ext uri="{FF2B5EF4-FFF2-40B4-BE49-F238E27FC236}">
                    <a16:creationId xmlns:a16="http://schemas.microsoft.com/office/drawing/2014/main" id="{6F5B972A-1F14-9D04-0414-35DE99AF4A1E}"/>
                  </a:ext>
                </a:extLst>
              </p:cNvPr>
              <p:cNvSpPr txBox="1"/>
              <p:nvPr/>
            </p:nvSpPr>
            <p:spPr>
              <a:xfrm>
                <a:off x="3589782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69C721F8-D277-3EC1-5736-869BCDB925F1}"/>
                  </a:ext>
                </a:extLst>
              </p:cNvPr>
              <p:cNvSpPr txBox="1"/>
              <p:nvPr/>
            </p:nvSpPr>
            <p:spPr>
              <a:xfrm>
                <a:off x="3840654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文本框 11">
                <a:extLst>
                  <a:ext uri="{FF2B5EF4-FFF2-40B4-BE49-F238E27FC236}">
                    <a16:creationId xmlns:a16="http://schemas.microsoft.com/office/drawing/2014/main" id="{E3FF4E83-56FD-2A5C-56EA-BBFB93ED7EB7}"/>
                  </a:ext>
                </a:extLst>
              </p:cNvPr>
              <p:cNvSpPr txBox="1"/>
              <p:nvPr/>
            </p:nvSpPr>
            <p:spPr>
              <a:xfrm>
                <a:off x="4091526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" name="文本框 12">
                <a:extLst>
                  <a:ext uri="{FF2B5EF4-FFF2-40B4-BE49-F238E27FC236}">
                    <a16:creationId xmlns:a16="http://schemas.microsoft.com/office/drawing/2014/main" id="{C85674E1-DD21-B041-B458-0D31460FCB7E}"/>
                  </a:ext>
                </a:extLst>
              </p:cNvPr>
              <p:cNvSpPr txBox="1"/>
              <p:nvPr/>
            </p:nvSpPr>
            <p:spPr>
              <a:xfrm>
                <a:off x="4342398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3C90395A-6332-6B7F-D379-AEED2C27A27F}"/>
                  </a:ext>
                </a:extLst>
              </p:cNvPr>
              <p:cNvSpPr txBox="1"/>
              <p:nvPr/>
            </p:nvSpPr>
            <p:spPr>
              <a:xfrm>
                <a:off x="4593270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956E7AC8-15E5-EBB9-D878-554ACC17FB95}"/>
                  </a:ext>
                </a:extLst>
              </p:cNvPr>
              <p:cNvSpPr txBox="1"/>
              <p:nvPr/>
            </p:nvSpPr>
            <p:spPr>
              <a:xfrm>
                <a:off x="4844142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B499F1EA-4A5B-320B-73D7-5C9ECCD1ACD1}"/>
                  </a:ext>
                </a:extLst>
              </p:cNvPr>
              <p:cNvSpPr txBox="1"/>
              <p:nvPr/>
            </p:nvSpPr>
            <p:spPr>
              <a:xfrm>
                <a:off x="5095014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69349D3E-843E-C338-2F67-B0A6DFD33596}"/>
                  </a:ext>
                </a:extLst>
              </p:cNvPr>
              <p:cNvSpPr txBox="1"/>
              <p:nvPr/>
            </p:nvSpPr>
            <p:spPr>
              <a:xfrm>
                <a:off x="5345886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94C8F8CD-455C-6081-4A62-97BCCA5A70EA}"/>
                  </a:ext>
                </a:extLst>
              </p:cNvPr>
              <p:cNvSpPr txBox="1"/>
              <p:nvPr/>
            </p:nvSpPr>
            <p:spPr>
              <a:xfrm>
                <a:off x="5596753" y="3590094"/>
                <a:ext cx="30480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9" name="直接连接符 18">
                <a:extLst>
                  <a:ext uri="{FF2B5EF4-FFF2-40B4-BE49-F238E27FC236}">
                    <a16:creationId xmlns:a16="http://schemas.microsoft.com/office/drawing/2014/main" id="{ADA27E47-F367-AF16-2CB1-6A0CA57110C4}"/>
                  </a:ext>
                </a:extLst>
              </p:cNvPr>
              <p:cNvCxnSpPr/>
              <p:nvPr/>
            </p:nvCxnSpPr>
            <p:spPr>
              <a:xfrm>
                <a:off x="2353528" y="3609977"/>
                <a:ext cx="4255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153057E3-504C-17FB-EF8B-D5FDDCA2E1FC}"/>
                  </a:ext>
                </a:extLst>
              </p:cNvPr>
              <p:cNvSpPr txBox="1"/>
              <p:nvPr/>
            </p:nvSpPr>
            <p:spPr>
              <a:xfrm rot="18754807">
                <a:off x="2373093" y="3243326"/>
                <a:ext cx="6478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RNA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1" name="直接连接符 20">
                <a:extLst>
                  <a:ext uri="{FF2B5EF4-FFF2-40B4-BE49-F238E27FC236}">
                    <a16:creationId xmlns:a16="http://schemas.microsoft.com/office/drawing/2014/main" id="{3F148A4C-9C12-21C9-CAC3-9315B464FEE9}"/>
                  </a:ext>
                </a:extLst>
              </p:cNvPr>
              <p:cNvCxnSpPr/>
              <p:nvPr/>
            </p:nvCxnSpPr>
            <p:spPr>
              <a:xfrm>
                <a:off x="2870678" y="3609977"/>
                <a:ext cx="4255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文本框 21">
                <a:extLst>
                  <a:ext uri="{FF2B5EF4-FFF2-40B4-BE49-F238E27FC236}">
                    <a16:creationId xmlns:a16="http://schemas.microsoft.com/office/drawing/2014/main" id="{6176ABE3-292C-BA6E-62AB-787D0E614777}"/>
                  </a:ext>
                </a:extLst>
              </p:cNvPr>
              <p:cNvSpPr txBox="1"/>
              <p:nvPr/>
            </p:nvSpPr>
            <p:spPr>
              <a:xfrm rot="18754807">
                <a:off x="2869347" y="3195748"/>
                <a:ext cx="777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2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3" name="直接连接符 22">
                <a:extLst>
                  <a:ext uri="{FF2B5EF4-FFF2-40B4-BE49-F238E27FC236}">
                    <a16:creationId xmlns:a16="http://schemas.microsoft.com/office/drawing/2014/main" id="{2A5695C2-B983-70AA-DA5E-95AC4F2C148F}"/>
                  </a:ext>
                </a:extLst>
              </p:cNvPr>
              <p:cNvCxnSpPr/>
              <p:nvPr/>
            </p:nvCxnSpPr>
            <p:spPr>
              <a:xfrm>
                <a:off x="3350590" y="3609977"/>
                <a:ext cx="4255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文本框 23">
                <a:extLst>
                  <a:ext uri="{FF2B5EF4-FFF2-40B4-BE49-F238E27FC236}">
                    <a16:creationId xmlns:a16="http://schemas.microsoft.com/office/drawing/2014/main" id="{B941443B-675C-3FD4-FD85-04CEEF5F5237}"/>
                  </a:ext>
                </a:extLst>
              </p:cNvPr>
              <p:cNvSpPr txBox="1"/>
              <p:nvPr/>
            </p:nvSpPr>
            <p:spPr>
              <a:xfrm rot="18754807">
                <a:off x="3349259" y="3195748"/>
                <a:ext cx="777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3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5" name="直接连接符 24">
                <a:extLst>
                  <a:ext uri="{FF2B5EF4-FFF2-40B4-BE49-F238E27FC236}">
                    <a16:creationId xmlns:a16="http://schemas.microsoft.com/office/drawing/2014/main" id="{A8084846-9EC5-80E0-E06B-0419F24A47A7}"/>
                  </a:ext>
                </a:extLst>
              </p:cNvPr>
              <p:cNvCxnSpPr/>
              <p:nvPr/>
            </p:nvCxnSpPr>
            <p:spPr>
              <a:xfrm>
                <a:off x="3862795" y="3609977"/>
                <a:ext cx="4255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" name="文本框 25">
                <a:extLst>
                  <a:ext uri="{FF2B5EF4-FFF2-40B4-BE49-F238E27FC236}">
                    <a16:creationId xmlns:a16="http://schemas.microsoft.com/office/drawing/2014/main" id="{C02BDF11-ADCF-6780-C883-978173C016FC}"/>
                  </a:ext>
                </a:extLst>
              </p:cNvPr>
              <p:cNvSpPr txBox="1"/>
              <p:nvPr/>
            </p:nvSpPr>
            <p:spPr>
              <a:xfrm rot="18754807">
                <a:off x="3870517" y="3195748"/>
                <a:ext cx="777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4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" name="直接连接符 26">
                <a:extLst>
                  <a:ext uri="{FF2B5EF4-FFF2-40B4-BE49-F238E27FC236}">
                    <a16:creationId xmlns:a16="http://schemas.microsoft.com/office/drawing/2014/main" id="{A85EF802-EA3C-7D4B-39A5-AC9A739828F4}"/>
                  </a:ext>
                </a:extLst>
              </p:cNvPr>
              <p:cNvCxnSpPr/>
              <p:nvPr/>
            </p:nvCxnSpPr>
            <p:spPr>
              <a:xfrm>
                <a:off x="4371727" y="3609977"/>
                <a:ext cx="4255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文本框 27">
                <a:extLst>
                  <a:ext uri="{FF2B5EF4-FFF2-40B4-BE49-F238E27FC236}">
                    <a16:creationId xmlns:a16="http://schemas.microsoft.com/office/drawing/2014/main" id="{09286526-4AC2-256D-29E1-6FF75BF98606}"/>
                  </a:ext>
                </a:extLst>
              </p:cNvPr>
              <p:cNvSpPr txBox="1"/>
              <p:nvPr/>
            </p:nvSpPr>
            <p:spPr>
              <a:xfrm rot="18754807">
                <a:off x="4370396" y="3195748"/>
                <a:ext cx="777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5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9" name="直接连接符 28">
                <a:extLst>
                  <a:ext uri="{FF2B5EF4-FFF2-40B4-BE49-F238E27FC236}">
                    <a16:creationId xmlns:a16="http://schemas.microsoft.com/office/drawing/2014/main" id="{435D123A-7B69-E0BC-2CFB-0EEA88925EDC}"/>
                  </a:ext>
                </a:extLst>
              </p:cNvPr>
              <p:cNvCxnSpPr/>
              <p:nvPr/>
            </p:nvCxnSpPr>
            <p:spPr>
              <a:xfrm>
                <a:off x="4877334" y="3609977"/>
                <a:ext cx="4255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0" name="文本框 29">
                <a:extLst>
                  <a:ext uri="{FF2B5EF4-FFF2-40B4-BE49-F238E27FC236}">
                    <a16:creationId xmlns:a16="http://schemas.microsoft.com/office/drawing/2014/main" id="{4D18E8CE-44E1-D44A-3F53-E181BB789059}"/>
                  </a:ext>
                </a:extLst>
              </p:cNvPr>
              <p:cNvSpPr txBox="1"/>
              <p:nvPr/>
            </p:nvSpPr>
            <p:spPr>
              <a:xfrm rot="18754807">
                <a:off x="4876003" y="3195748"/>
                <a:ext cx="777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6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1" name="直接连接符 30">
                <a:extLst>
                  <a:ext uri="{FF2B5EF4-FFF2-40B4-BE49-F238E27FC236}">
                    <a16:creationId xmlns:a16="http://schemas.microsoft.com/office/drawing/2014/main" id="{5A47A196-891F-ECB9-FA87-996ABAA470B3}"/>
                  </a:ext>
                </a:extLst>
              </p:cNvPr>
              <p:cNvCxnSpPr/>
              <p:nvPr/>
            </p:nvCxnSpPr>
            <p:spPr>
              <a:xfrm>
                <a:off x="5387508" y="3609977"/>
                <a:ext cx="42557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文本框 31">
                <a:extLst>
                  <a:ext uri="{FF2B5EF4-FFF2-40B4-BE49-F238E27FC236}">
                    <a16:creationId xmlns:a16="http://schemas.microsoft.com/office/drawing/2014/main" id="{DF3FC777-B2F0-90A8-A7C0-624ADB437E14}"/>
                  </a:ext>
                </a:extLst>
              </p:cNvPr>
              <p:cNvSpPr txBox="1"/>
              <p:nvPr/>
            </p:nvSpPr>
            <p:spPr>
              <a:xfrm rot="18754807">
                <a:off x="5377124" y="3195748"/>
                <a:ext cx="77707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gRNA7</a:t>
                </a:r>
                <a:endParaRPr lang="zh-CN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文本框 32">
                <a:extLst>
                  <a:ext uri="{FF2B5EF4-FFF2-40B4-BE49-F238E27FC236}">
                    <a16:creationId xmlns:a16="http://schemas.microsoft.com/office/drawing/2014/main" id="{C70C94FB-BAB0-93EE-4F24-0A9B67B71992}"/>
                  </a:ext>
                </a:extLst>
              </p:cNvPr>
              <p:cNvSpPr txBox="1"/>
              <p:nvPr/>
            </p:nvSpPr>
            <p:spPr>
              <a:xfrm>
                <a:off x="5811576" y="4957183"/>
                <a:ext cx="690913" cy="400110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: WT </a:t>
                </a:r>
              </a:p>
              <a:p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: Mock 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34" name="对象 33"/>
              <p:cNvGraphicFramePr>
                <a:graphicFrameLocks noChangeAspect="1"/>
              </p:cNvGraphicFramePr>
              <p:nvPr/>
            </p:nvGraphicFramePr>
            <p:xfrm>
              <a:off x="2105120" y="3812473"/>
              <a:ext cx="3763643" cy="154800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Image" r:id="rId3" imgW="4859333" imgH="1997972" progId="Photoshop.Image.12">
                      <p:embed/>
                    </p:oleObj>
                  </mc:Choice>
                  <mc:Fallback>
                    <p:oleObj name="Image" r:id="rId3" imgW="4859333" imgH="1997972" progId="Photoshop.Image.12">
                      <p:embed/>
                      <p:pic>
                        <p:nvPicPr>
                          <p:cNvPr id="34" name="对象 33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2105120" y="3812473"/>
                            <a:ext cx="3763643" cy="154800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36" name="Rectangle 4"/>
            <p:cNvSpPr>
              <a:spLocks noChangeArrowheads="1"/>
            </p:cNvSpPr>
            <p:nvPr/>
          </p:nvSpPr>
          <p:spPr bwMode="auto">
            <a:xfrm>
              <a:off x="3862328" y="1014459"/>
              <a:ext cx="1728000" cy="20478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r" eaLnBrk="0" hangingPunct="0">
                <a:defRPr/>
              </a:pPr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a</a:t>
              </a:r>
            </a:p>
          </p:txBody>
        </p:sp>
        <p:sp>
          <p:nvSpPr>
            <p:cNvPr id="37" name="Rectangle 5"/>
            <p:cNvSpPr>
              <a:spLocks noChangeArrowheads="1"/>
            </p:cNvSpPr>
            <p:nvPr/>
          </p:nvSpPr>
          <p:spPr bwMode="auto">
            <a:xfrm>
              <a:off x="5577888" y="1219246"/>
              <a:ext cx="576000" cy="203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eaLnBrk="0" hangingPunct="0">
                <a:defRPr/>
              </a:pPr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b</a:t>
              </a:r>
            </a:p>
          </p:txBody>
        </p:sp>
        <p:sp>
          <p:nvSpPr>
            <p:cNvPr id="38" name="Rectangle 6"/>
            <p:cNvSpPr>
              <a:spLocks noChangeArrowheads="1"/>
            </p:cNvSpPr>
            <p:nvPr/>
          </p:nvSpPr>
          <p:spPr bwMode="auto">
            <a:xfrm>
              <a:off x="6168519" y="1014459"/>
              <a:ext cx="461962" cy="20478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 eaLnBrk="0" hangingPunct="0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a</a:t>
              </a:r>
            </a:p>
          </p:txBody>
        </p:sp>
        <p:sp>
          <p:nvSpPr>
            <p:cNvPr id="39" name="Rectangle 7"/>
            <p:cNvSpPr>
              <a:spLocks noChangeArrowheads="1"/>
            </p:cNvSpPr>
            <p:nvPr/>
          </p:nvSpPr>
          <p:spPr bwMode="auto">
            <a:xfrm>
              <a:off x="6541581" y="1219246"/>
              <a:ext cx="373063" cy="203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 eaLnBrk="0" hangingPunct="0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</a:p>
          </p:txBody>
        </p:sp>
        <p:sp>
          <p:nvSpPr>
            <p:cNvPr id="40" name="Rectangle 8"/>
            <p:cNvSpPr>
              <a:spLocks noChangeArrowheads="1"/>
            </p:cNvSpPr>
            <p:nvPr/>
          </p:nvSpPr>
          <p:spPr bwMode="auto">
            <a:xfrm>
              <a:off x="6806694" y="1014459"/>
              <a:ext cx="374650" cy="20478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 eaLnBrk="0" hangingPunct="0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41" name="Rectangle 9"/>
            <p:cNvSpPr>
              <a:spLocks noChangeArrowheads="1"/>
            </p:cNvSpPr>
            <p:nvPr/>
          </p:nvSpPr>
          <p:spPr bwMode="auto">
            <a:xfrm>
              <a:off x="7186106" y="1219246"/>
              <a:ext cx="377825" cy="203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 eaLnBrk="0" hangingPunct="0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</a:p>
          </p:txBody>
        </p:sp>
        <p:sp>
          <p:nvSpPr>
            <p:cNvPr id="42" name="Rectangle 10"/>
            <p:cNvSpPr>
              <a:spLocks noChangeArrowheads="1"/>
            </p:cNvSpPr>
            <p:nvPr/>
          </p:nvSpPr>
          <p:spPr bwMode="auto">
            <a:xfrm>
              <a:off x="7492494" y="1014459"/>
              <a:ext cx="376237" cy="204787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 eaLnBrk="0" hangingPunct="0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</a:p>
          </p:txBody>
        </p:sp>
        <p:sp>
          <p:nvSpPr>
            <p:cNvPr id="43" name="Rectangle 11"/>
            <p:cNvSpPr>
              <a:spLocks noChangeArrowheads="1"/>
            </p:cNvSpPr>
            <p:nvPr/>
          </p:nvSpPr>
          <p:spPr bwMode="auto">
            <a:xfrm>
              <a:off x="7816344" y="1219246"/>
              <a:ext cx="269875" cy="203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 eaLnBrk="0" hangingPunct="0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</a:t>
              </a:r>
            </a:p>
          </p:txBody>
        </p:sp>
        <p:sp>
          <p:nvSpPr>
            <p:cNvPr id="44" name="Rectangle 5"/>
            <p:cNvSpPr>
              <a:spLocks noChangeArrowheads="1"/>
            </p:cNvSpPr>
            <p:nvPr/>
          </p:nvSpPr>
          <p:spPr bwMode="auto">
            <a:xfrm>
              <a:off x="6190744" y="1219246"/>
              <a:ext cx="252412" cy="20320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pPr algn="ctr" eaLnBrk="0" hangingPunct="0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b</a:t>
              </a:r>
            </a:p>
          </p:txBody>
        </p:sp>
        <p:sp>
          <p:nvSpPr>
            <p:cNvPr id="45" name="Rectangle 89"/>
            <p:cNvSpPr>
              <a:spLocks noChangeArrowheads="1"/>
            </p:cNvSpPr>
            <p:nvPr/>
          </p:nvSpPr>
          <p:spPr bwMode="auto">
            <a:xfrm>
              <a:off x="7178169" y="1014458"/>
              <a:ext cx="179387" cy="20478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ffectLst/>
          </p:spPr>
          <p:txBody>
            <a:bodyPr wrap="none" anchor="ctr"/>
            <a:lstStyle/>
            <a:p>
              <a:pPr algn="ctr"/>
              <a:r>
                <a:rPr lang="en-US" altLang="zh-CN" sz="1000" b="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a</a:t>
              </a:r>
            </a:p>
          </p:txBody>
        </p:sp>
        <p:cxnSp>
          <p:nvCxnSpPr>
            <p:cNvPr id="46" name="Straight Connector 19"/>
            <p:cNvCxnSpPr/>
            <p:nvPr/>
          </p:nvCxnSpPr>
          <p:spPr>
            <a:xfrm>
              <a:off x="3603160" y="1217658"/>
              <a:ext cx="4788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文本框 46"/>
            <p:cNvSpPr txBox="1"/>
            <p:nvPr/>
          </p:nvSpPr>
          <p:spPr>
            <a:xfrm>
              <a:off x="3529154" y="1218824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’UT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8023922" y="1218824"/>
              <a:ext cx="548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’UTR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矩形 48"/>
            <p:cNvSpPr/>
            <p:nvPr/>
          </p:nvSpPr>
          <p:spPr>
            <a:xfrm>
              <a:off x="3876878" y="1041583"/>
              <a:ext cx="191610" cy="1440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endParaRPr lang="zh-CN" altLang="en-US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矩形 49"/>
            <p:cNvSpPr/>
            <p:nvPr/>
          </p:nvSpPr>
          <p:spPr>
            <a:xfrm>
              <a:off x="3763903" y="1000722"/>
              <a:ext cx="363803" cy="21544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l-GR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α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矩形 50"/>
            <p:cNvSpPr/>
            <p:nvPr/>
          </p:nvSpPr>
          <p:spPr>
            <a:xfrm>
              <a:off x="6168511" y="1660436"/>
              <a:ext cx="2271573" cy="108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矩形 51"/>
            <p:cNvSpPr/>
            <p:nvPr/>
          </p:nvSpPr>
          <p:spPr>
            <a:xfrm>
              <a:off x="5924325" y="1660436"/>
              <a:ext cx="252034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3" name="矩形 52"/>
            <p:cNvSpPr/>
            <p:nvPr/>
          </p:nvSpPr>
          <p:spPr>
            <a:xfrm>
              <a:off x="6541573" y="1952258"/>
              <a:ext cx="1898510" cy="108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矩形 53"/>
            <p:cNvSpPr/>
            <p:nvPr/>
          </p:nvSpPr>
          <p:spPr>
            <a:xfrm>
              <a:off x="6294190" y="1952258"/>
              <a:ext cx="252034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矩形 54"/>
            <p:cNvSpPr/>
            <p:nvPr/>
          </p:nvSpPr>
          <p:spPr>
            <a:xfrm>
              <a:off x="6806686" y="2244080"/>
              <a:ext cx="1633397" cy="108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矩形 55"/>
            <p:cNvSpPr/>
            <p:nvPr/>
          </p:nvSpPr>
          <p:spPr>
            <a:xfrm>
              <a:off x="6555642" y="2244080"/>
              <a:ext cx="252034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矩形 56"/>
            <p:cNvSpPr/>
            <p:nvPr/>
          </p:nvSpPr>
          <p:spPr>
            <a:xfrm>
              <a:off x="7178161" y="2535902"/>
              <a:ext cx="1261923" cy="108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矩形 57"/>
            <p:cNvSpPr/>
            <p:nvPr/>
          </p:nvSpPr>
          <p:spPr>
            <a:xfrm>
              <a:off x="6931189" y="2535902"/>
              <a:ext cx="252034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矩形 58"/>
            <p:cNvSpPr/>
            <p:nvPr/>
          </p:nvSpPr>
          <p:spPr>
            <a:xfrm>
              <a:off x="7492486" y="2827724"/>
              <a:ext cx="947597" cy="108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矩形 59"/>
            <p:cNvSpPr/>
            <p:nvPr/>
          </p:nvSpPr>
          <p:spPr>
            <a:xfrm>
              <a:off x="7249688" y="2827724"/>
              <a:ext cx="252034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矩形 60"/>
            <p:cNvSpPr/>
            <p:nvPr/>
          </p:nvSpPr>
          <p:spPr>
            <a:xfrm>
              <a:off x="7816336" y="3119546"/>
              <a:ext cx="623747" cy="108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矩形 61"/>
            <p:cNvSpPr/>
            <p:nvPr/>
          </p:nvSpPr>
          <p:spPr>
            <a:xfrm>
              <a:off x="7568182" y="3119546"/>
              <a:ext cx="252034" cy="108000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3" name="直接箭头连接符 62"/>
            <p:cNvCxnSpPr/>
            <p:nvPr/>
          </p:nvCxnSpPr>
          <p:spPr>
            <a:xfrm>
              <a:off x="6032521" y="1602779"/>
              <a:ext cx="3184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箭头连接符 63"/>
            <p:cNvCxnSpPr/>
            <p:nvPr/>
          </p:nvCxnSpPr>
          <p:spPr>
            <a:xfrm>
              <a:off x="6390402" y="1899015"/>
              <a:ext cx="3184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接箭头连接符 64"/>
            <p:cNvCxnSpPr/>
            <p:nvPr/>
          </p:nvCxnSpPr>
          <p:spPr>
            <a:xfrm>
              <a:off x="6626708" y="2186689"/>
              <a:ext cx="3184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箭头连接符 65"/>
            <p:cNvCxnSpPr/>
            <p:nvPr/>
          </p:nvCxnSpPr>
          <p:spPr>
            <a:xfrm>
              <a:off x="7027399" y="2484641"/>
              <a:ext cx="3184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接箭头连接符 66"/>
            <p:cNvCxnSpPr/>
            <p:nvPr/>
          </p:nvCxnSpPr>
          <p:spPr>
            <a:xfrm>
              <a:off x="7345897" y="2777455"/>
              <a:ext cx="3184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接箭头连接符 67"/>
            <p:cNvCxnSpPr/>
            <p:nvPr/>
          </p:nvCxnSpPr>
          <p:spPr>
            <a:xfrm>
              <a:off x="7631076" y="3062273"/>
              <a:ext cx="31849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箭头连接符 68"/>
            <p:cNvCxnSpPr/>
            <p:nvPr/>
          </p:nvCxnSpPr>
          <p:spPr>
            <a:xfrm flipH="1">
              <a:off x="6506452" y="1602779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箭头连接符 69"/>
            <p:cNvCxnSpPr/>
            <p:nvPr/>
          </p:nvCxnSpPr>
          <p:spPr>
            <a:xfrm flipH="1">
              <a:off x="6787806" y="1899015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箭头连接符 70"/>
            <p:cNvCxnSpPr/>
            <p:nvPr/>
          </p:nvCxnSpPr>
          <p:spPr>
            <a:xfrm flipH="1">
              <a:off x="7028964" y="2186689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箭头连接符 71"/>
            <p:cNvCxnSpPr/>
            <p:nvPr/>
          </p:nvCxnSpPr>
          <p:spPr>
            <a:xfrm flipH="1">
              <a:off x="7440945" y="2484641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箭头连接符 72"/>
            <p:cNvCxnSpPr/>
            <p:nvPr/>
          </p:nvCxnSpPr>
          <p:spPr>
            <a:xfrm flipH="1">
              <a:off x="7732353" y="2777455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箭头连接符 73"/>
            <p:cNvCxnSpPr/>
            <p:nvPr/>
          </p:nvCxnSpPr>
          <p:spPr>
            <a:xfrm flipH="1">
              <a:off x="8124232" y="3062273"/>
              <a:ext cx="180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箭头连接符 74"/>
            <p:cNvCxnSpPr/>
            <p:nvPr/>
          </p:nvCxnSpPr>
          <p:spPr>
            <a:xfrm>
              <a:off x="4262620" y="1288426"/>
              <a:ext cx="14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箭头连接符 75"/>
            <p:cNvCxnSpPr/>
            <p:nvPr/>
          </p:nvCxnSpPr>
          <p:spPr>
            <a:xfrm rot="10800000">
              <a:off x="4515503" y="1288426"/>
              <a:ext cx="1440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文本框 76"/>
            <p:cNvSpPr txBox="1"/>
            <p:nvPr/>
          </p:nvSpPr>
          <p:spPr>
            <a:xfrm>
              <a:off x="5290956" y="1585847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RNA2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5671956" y="1883147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RNA3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>
              <a:off x="5948181" y="2168907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RNA4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>
              <a:off x="6310131" y="2460729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RNA5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文本框 80"/>
            <p:cNvSpPr txBox="1"/>
            <p:nvPr/>
          </p:nvSpPr>
          <p:spPr>
            <a:xfrm>
              <a:off x="6605406" y="2752551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RNA6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6957831" y="3044373"/>
              <a:ext cx="6335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gRNA7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文本框 82"/>
            <p:cNvSpPr txBox="1"/>
            <p:nvPr/>
          </p:nvSpPr>
          <p:spPr>
            <a:xfrm>
              <a:off x="4162035" y="1313967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RNA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4" name="直接连接符 83"/>
            <p:cNvCxnSpPr/>
            <p:nvPr/>
          </p:nvCxnSpPr>
          <p:spPr>
            <a:xfrm flipH="1">
              <a:off x="5792020" y="1211394"/>
              <a:ext cx="185699" cy="21600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连接符 84"/>
            <p:cNvCxnSpPr/>
            <p:nvPr/>
          </p:nvCxnSpPr>
          <p:spPr>
            <a:xfrm flipH="1">
              <a:off x="5866803" y="1211394"/>
              <a:ext cx="185699" cy="216000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34"/>
            <p:cNvSpPr txBox="1"/>
            <p:nvPr/>
          </p:nvSpPr>
          <p:spPr>
            <a:xfrm>
              <a:off x="3307616" y="90186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>
              <a:off x="3307616" y="3569987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310092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53</Words>
  <Application>Microsoft Office PowerPoint</Application>
  <PresentationFormat>宽屏</PresentationFormat>
  <Paragraphs>48</Paragraphs>
  <Slides>1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Imag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ellissa 、</dc:creator>
  <cp:lastModifiedBy>Mellissa 、</cp:lastModifiedBy>
  <cp:revision>13</cp:revision>
  <dcterms:created xsi:type="dcterms:W3CDTF">2025-02-09T08:35:15Z</dcterms:created>
  <dcterms:modified xsi:type="dcterms:W3CDTF">2025-02-09T13:48:57Z</dcterms:modified>
</cp:coreProperties>
</file>